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8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093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864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718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686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313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297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894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717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10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697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624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6ED7C6-E134-4C51-A1E2-70A524B0EBC9}" type="datetimeFigureOut">
              <a:rPr lang="en-US" smtClean="0"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0AF2D6-2F2F-40EA-9E84-0205EE6F81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970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gif"/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gif"/><Relationship Id="rId4" Type="http://schemas.openxmlformats.org/officeDocument/2006/relationships/image" Target="../media/image7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2FD217B-A201-4EF3-B427-7F173C80ECCB}"/>
              </a:ext>
            </a:extLst>
          </p:cNvPr>
          <p:cNvSpPr txBox="1"/>
          <p:nvPr/>
        </p:nvSpPr>
        <p:spPr>
          <a:xfrm>
            <a:off x="1597533" y="182880"/>
            <a:ext cx="59489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Occasion specific localization animation for individual 13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8E605EE6-883A-4311-93F9-2BB667EB2436}"/>
              </a:ext>
            </a:extLst>
          </p:cNvPr>
          <p:cNvGrpSpPr>
            <a:grpSpLocks noChangeAspect="1"/>
          </p:cNvGrpSpPr>
          <p:nvPr/>
        </p:nvGrpSpPr>
        <p:grpSpPr>
          <a:xfrm>
            <a:off x="1597534" y="685800"/>
            <a:ext cx="5948932" cy="5943600"/>
            <a:chOff x="2566877" y="630828"/>
            <a:chExt cx="5634052" cy="562900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B40DE87-5B9D-4472-B19E-55B9FE9D575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9129" y="630828"/>
              <a:ext cx="2971800" cy="29718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FFDFF12-134A-4874-8A2F-16CA35EC9DA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6877" y="630828"/>
              <a:ext cx="2971800" cy="29718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BCE676D-C3B0-4AE8-AA79-B8ECFC4F9C5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9129" y="3288030"/>
              <a:ext cx="2971800" cy="29718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B9C5A62-CE85-48AD-9385-9422163B199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6877" y="3288030"/>
              <a:ext cx="2971800" cy="2971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92459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379AFF3-3577-41D8-B664-EA9254A09965}"/>
              </a:ext>
            </a:extLst>
          </p:cNvPr>
          <p:cNvSpPr txBox="1"/>
          <p:nvPr/>
        </p:nvSpPr>
        <p:spPr>
          <a:xfrm>
            <a:off x="1596632" y="182880"/>
            <a:ext cx="5950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Occasion specific localization animation for individual 3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CA883966-F3B6-4E98-9011-85D0FA073627}"/>
              </a:ext>
            </a:extLst>
          </p:cNvPr>
          <p:cNvGrpSpPr>
            <a:grpSpLocks noChangeAspect="1"/>
          </p:cNvGrpSpPr>
          <p:nvPr/>
        </p:nvGrpSpPr>
        <p:grpSpPr>
          <a:xfrm>
            <a:off x="1596632" y="685800"/>
            <a:ext cx="5950735" cy="5943600"/>
            <a:chOff x="2495550" y="651782"/>
            <a:chExt cx="5631554" cy="562480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DDAEDD8-9108-4AD8-B53D-37E4702087C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55304" y="651782"/>
              <a:ext cx="2971800" cy="29718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26E3974-6184-4610-B2BD-2BBAEC4F6AF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5550" y="651782"/>
              <a:ext cx="2971800" cy="29718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078A2C8-3D85-4BA3-B738-FA2B2ABB634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55304" y="3304784"/>
              <a:ext cx="2971800" cy="29718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3A891E6D-154A-4139-A841-D67D7FCDA5C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5550" y="3304784"/>
              <a:ext cx="2971800" cy="2971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61011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4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han Hostetter</dc:creator>
  <cp:lastModifiedBy>Nathan Hostetter</cp:lastModifiedBy>
  <cp:revision>1</cp:revision>
  <dcterms:created xsi:type="dcterms:W3CDTF">2019-06-29T19:49:34Z</dcterms:created>
  <dcterms:modified xsi:type="dcterms:W3CDTF">2019-06-29T19:53:37Z</dcterms:modified>
</cp:coreProperties>
</file>